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BEB4E7-221D-4279-B0F5-A96D6ED16E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0F6FDE-4BBF-478F-8972-FB8EA6F25D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91B8B1-9DFB-4D4B-BA54-933F05EF7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5BFAAE-52FC-4AB1-A832-E98CCAF338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20990D-D65D-443B-A60A-869D8EB92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66482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B110D9-930D-4F25-8DE6-1CB1EACEA5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F711FD-F525-4B11-98D2-4BD8486EDD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228996-9444-409E-9520-8A1B610C58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C63CF5-7EC9-4BC2-AD1E-11E958270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1D79F1-DB8E-4FA0-90AB-F520124AD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43910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278FB0-2104-4BEE-9E1E-E7334436B1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253344-EB26-4249-922A-1162A7B71C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C1F1D3-1C6E-41C7-94FA-CAC5DD784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9EBD40-E21D-47AC-B13A-A06B99805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2FB60C-FA37-47C6-AD29-90F2DB69D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98369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867B3B-CE3D-4CF1-A144-65CE8F430F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CAF8D9-72DB-49C9-B593-439F51E063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7FAEB6-EF39-4AA1-9CAC-57F5C752E2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BD5E24-444E-4F01-A0B6-1B1370BFD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2D6420-D5E9-40FB-A625-72910F5E80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38820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7665E3-1F87-467F-B189-4021D1AAA7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74344A-DF24-4E52-8CD0-BA1653BEAD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48A4A6-DDB6-47CA-882A-7959084A48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C02B08-1C0C-4125-A1F1-60A5FE962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AAF62B-19FF-4299-97D9-4696099FD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52979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640C84-03CC-4A5E-958C-FD32CBE7CE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A7BC61-7780-4A34-B135-40D31FECBC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69B07F-52E8-41AF-AD66-FB754154BE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DE82EB-2AD0-42F0-9340-AC4FAF074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12AA32-706A-49D2-B0EE-449C1F2EE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CEFB53-92AA-4745-BF88-A5A552F512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90683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4F9105-2D0B-4238-8054-4CD004657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72D637-FDB7-4F68-A90E-DA7EC7DC00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BB24E2-98C3-4365-946C-CB66200610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923296E-5074-48D0-9195-B0DFDA7B65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FF02B2-6289-498E-A13E-82E5D67F84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5F1D0AB-824A-4EDD-825B-AFF1C0E4B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096F47-E02D-40B5-A563-6482B7789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B9068DB-F4A6-4A27-919E-423240A37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32283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1A17B5-92A7-442C-9772-3507087F71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0D721E6-0EF9-4214-936E-805D8DD6F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4CB7CA-A8F1-4563-9888-73C77ABC4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79C352-EECC-42D5-9092-A8A6E8EFA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50473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73C75ED-67E2-4E20-935C-C6239C1E0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6FF6AC-2DA2-4BA7-B28A-33A770BB9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5BE755-D94D-4495-9BD4-E6F44AC11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94827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20561B-774F-40C1-BDBF-9E2F25821F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FBA1DE-C105-425B-995B-B69F3005A9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7EAB2B-5940-4415-BE35-F5C77CB0DB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0A5DAA-F929-4E7B-9E3A-E1860F80B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46C0C0-520B-4853-80BD-4FA1BBF72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8A6069-ABEA-4D85-8B7F-C7413A979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70862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3FAC87-AF3A-4797-9CFA-19DE26C499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265F82-712F-447E-A6D2-3DC6CB6C59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1AB5D1-A797-4204-90FD-5596B2B5DF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C534C8-AF4A-4167-ADDC-8E4BD4E93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5D9A31-050A-4168-89EF-A50064282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1E8208-F19D-448A-BFF2-D0E18D7E0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32387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D698F3C-3EE2-4CDC-A6CE-E05A5DC8B9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416F1A-A477-44AA-8EF1-ED96483DBA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5E1115-BC57-4C93-825E-5524CBD10E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83740-A8FB-4DEC-BFEC-25A16695D089}" type="datetimeFigureOut">
              <a:rPr lang="en-IN" smtClean="0"/>
              <a:t>06-06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C2DC8B-AC93-448D-B4F0-53BF244531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E95153-51D8-4EAE-8C7C-127FB0C4A26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7FFEF2-C868-4414-8A97-831DA3E61C2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85609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EB26549E-4441-4057-841D-3CDA74372730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325120" y="314236"/>
            <a:ext cx="2966719" cy="25603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FAE98CD-016E-4C16-A225-B525BE54A624}"/>
              </a:ext>
            </a:extLst>
          </p:cNvPr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885076" y="245133"/>
            <a:ext cx="3208577" cy="26931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5986A4F-2002-4DE5-ACD7-C45A757CEE02}"/>
              </a:ext>
            </a:extLst>
          </p:cNvPr>
          <p:cNvPicPr/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6010633" y="371510"/>
            <a:ext cx="2997199" cy="27622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0C1454C-5331-4D65-8F22-673171AEB5FC}"/>
              </a:ext>
            </a:extLst>
          </p:cNvPr>
          <p:cNvPicPr/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36254" y="2956380"/>
            <a:ext cx="3130629" cy="29821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82C95A2-7292-438B-AA2C-46CD58597070}"/>
              </a:ext>
            </a:extLst>
          </p:cNvPr>
          <p:cNvSpPr txBox="1"/>
          <p:nvPr/>
        </p:nvSpPr>
        <p:spPr>
          <a:xfrm>
            <a:off x="7806384" y="934300"/>
            <a:ext cx="8397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9.87%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F00EC7-8CF9-4430-BE7D-7C77EE6B2C06}"/>
              </a:ext>
            </a:extLst>
          </p:cNvPr>
          <p:cNvSpPr txBox="1"/>
          <p:nvPr/>
        </p:nvSpPr>
        <p:spPr>
          <a:xfrm>
            <a:off x="2368800" y="3491768"/>
            <a:ext cx="8397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11.23%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B2CF984-9FC6-4500-938C-CDBEF29B2D9B}"/>
              </a:ext>
            </a:extLst>
          </p:cNvPr>
          <p:cNvSpPr txBox="1"/>
          <p:nvPr/>
        </p:nvSpPr>
        <p:spPr>
          <a:xfrm>
            <a:off x="3779521" y="4734560"/>
            <a:ext cx="26758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1.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DA3EEDB-7388-4D65-8D9A-DF9B78E8F487}"/>
              </a:ext>
            </a:extLst>
          </p:cNvPr>
          <p:cNvSpPr txBox="1"/>
          <p:nvPr/>
        </p:nvSpPr>
        <p:spPr>
          <a:xfrm>
            <a:off x="536254" y="3242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E76BAED-86EA-4034-8F59-5A481935B833}"/>
              </a:ext>
            </a:extLst>
          </p:cNvPr>
          <p:cNvSpPr txBox="1"/>
          <p:nvPr/>
        </p:nvSpPr>
        <p:spPr>
          <a:xfrm>
            <a:off x="3482654" y="9338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112642F-9865-4FF7-82CD-B5B3A1E3946A}"/>
              </a:ext>
            </a:extLst>
          </p:cNvPr>
          <p:cNvSpPr txBox="1"/>
          <p:nvPr/>
        </p:nvSpPr>
        <p:spPr>
          <a:xfrm>
            <a:off x="6455325" y="87689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F3236EB-C288-429F-B755-4F1A0D97D68B}"/>
              </a:ext>
            </a:extLst>
          </p:cNvPr>
          <p:cNvSpPr txBox="1"/>
          <p:nvPr/>
        </p:nvSpPr>
        <p:spPr>
          <a:xfrm>
            <a:off x="552957" y="2776527"/>
            <a:ext cx="3679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53822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3B6CCD0-0AAB-4141-8CCA-66C5E683AE76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250918" y="362327"/>
            <a:ext cx="2726169" cy="23546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AFF47D3-FD49-4D8E-B811-405707184C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0629" y="336343"/>
            <a:ext cx="2726169" cy="235014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6966C3E-4D62-42B2-A9CE-BCCC4267D0E9}"/>
              </a:ext>
            </a:extLst>
          </p:cNvPr>
          <p:cNvPicPr/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311921" y="381119"/>
            <a:ext cx="2721080" cy="23105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D718EDB-AE94-43A1-947A-57F908E0DBB1}"/>
              </a:ext>
            </a:extLst>
          </p:cNvPr>
          <p:cNvPicPr/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3360090" y="3056744"/>
            <a:ext cx="2914335" cy="24240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3BD6CA5-8180-436E-BA58-331C12119CB8}"/>
              </a:ext>
            </a:extLst>
          </p:cNvPr>
          <p:cNvPicPr/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485454" y="2985624"/>
            <a:ext cx="3029905" cy="24748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CE88406-4BD8-4A73-8957-5C3CAFA0E7E9}"/>
              </a:ext>
            </a:extLst>
          </p:cNvPr>
          <p:cNvPicPr/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8157399" y="320159"/>
            <a:ext cx="2642682" cy="23460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FD27D2E8-58E9-4A8B-81F9-229DA5C678E6}"/>
              </a:ext>
            </a:extLst>
          </p:cNvPr>
          <p:cNvPicPr/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6363504" y="2955144"/>
            <a:ext cx="3258016" cy="26496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B438D18-EC68-44D3-8039-802CCCFF5950}"/>
              </a:ext>
            </a:extLst>
          </p:cNvPr>
          <p:cNvSpPr txBox="1"/>
          <p:nvPr/>
        </p:nvSpPr>
        <p:spPr>
          <a:xfrm>
            <a:off x="4342882" y="751840"/>
            <a:ext cx="700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0.09%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5C2226-9009-4F9C-9CB4-2C177E855237}"/>
              </a:ext>
            </a:extLst>
          </p:cNvPr>
          <p:cNvSpPr txBox="1"/>
          <p:nvPr/>
        </p:nvSpPr>
        <p:spPr>
          <a:xfrm>
            <a:off x="7302715" y="614680"/>
            <a:ext cx="596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6.3%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47421FA-80D3-417C-96C0-47CBECEDBF3D}"/>
              </a:ext>
            </a:extLst>
          </p:cNvPr>
          <p:cNvSpPr txBox="1"/>
          <p:nvPr/>
        </p:nvSpPr>
        <p:spPr>
          <a:xfrm>
            <a:off x="9992728" y="673824"/>
            <a:ext cx="596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4.5%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7885657-CF3B-4D85-B613-E04E6D955F46}"/>
              </a:ext>
            </a:extLst>
          </p:cNvPr>
          <p:cNvSpPr txBox="1"/>
          <p:nvPr/>
        </p:nvSpPr>
        <p:spPr>
          <a:xfrm>
            <a:off x="2662578" y="3457664"/>
            <a:ext cx="596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7.6%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38EAA26-3582-4C01-8719-94EE095677BF}"/>
              </a:ext>
            </a:extLst>
          </p:cNvPr>
          <p:cNvSpPr txBox="1"/>
          <p:nvPr/>
        </p:nvSpPr>
        <p:spPr>
          <a:xfrm>
            <a:off x="5502164" y="3392024"/>
            <a:ext cx="596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1.8%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E7EF334-8A29-4AC6-8DDC-BBAF05ED30F5}"/>
              </a:ext>
            </a:extLst>
          </p:cNvPr>
          <p:cNvSpPr txBox="1"/>
          <p:nvPr/>
        </p:nvSpPr>
        <p:spPr>
          <a:xfrm>
            <a:off x="8733860" y="3312151"/>
            <a:ext cx="596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4.2%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817FFFF-19EF-4C3F-88A4-84CA353655B2}"/>
              </a:ext>
            </a:extLst>
          </p:cNvPr>
          <p:cNvSpPr txBox="1"/>
          <p:nvPr/>
        </p:nvSpPr>
        <p:spPr>
          <a:xfrm>
            <a:off x="536254" y="3242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0E1E010-FCCC-4F96-9F23-9440BEAFADDD}"/>
              </a:ext>
            </a:extLst>
          </p:cNvPr>
          <p:cNvSpPr txBox="1"/>
          <p:nvPr/>
        </p:nvSpPr>
        <p:spPr>
          <a:xfrm>
            <a:off x="3086414" y="2226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7EC6370-C29B-4F5D-9EEC-8D6EA4C92BBC}"/>
              </a:ext>
            </a:extLst>
          </p:cNvPr>
          <p:cNvSpPr txBox="1"/>
          <p:nvPr/>
        </p:nvSpPr>
        <p:spPr>
          <a:xfrm>
            <a:off x="5656894" y="5274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9B56A5F-2ACC-4D0D-8C85-B1F3CE2AE3AB}"/>
              </a:ext>
            </a:extLst>
          </p:cNvPr>
          <p:cNvSpPr txBox="1"/>
          <p:nvPr/>
        </p:nvSpPr>
        <p:spPr>
          <a:xfrm>
            <a:off x="8501694" y="13402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6411AC6-5680-4350-975A-1A957A20469D}"/>
              </a:ext>
            </a:extLst>
          </p:cNvPr>
          <p:cNvSpPr txBox="1"/>
          <p:nvPr/>
        </p:nvSpPr>
        <p:spPr>
          <a:xfrm>
            <a:off x="851214" y="280610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916C177-D3A8-4574-81EF-72559D402834}"/>
              </a:ext>
            </a:extLst>
          </p:cNvPr>
          <p:cNvSpPr txBox="1"/>
          <p:nvPr/>
        </p:nvSpPr>
        <p:spPr>
          <a:xfrm>
            <a:off x="3635054" y="278578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A2BAC4D-5E82-4D5C-9314-F96855CDBA3C}"/>
              </a:ext>
            </a:extLst>
          </p:cNvPr>
          <p:cNvSpPr txBox="1"/>
          <p:nvPr/>
        </p:nvSpPr>
        <p:spPr>
          <a:xfrm>
            <a:off x="6655343" y="2724311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BDBE47E-8D68-449C-B91C-051C43200536}"/>
              </a:ext>
            </a:extLst>
          </p:cNvPr>
          <p:cNvSpPr txBox="1"/>
          <p:nvPr/>
        </p:nvSpPr>
        <p:spPr>
          <a:xfrm>
            <a:off x="3779521" y="5933440"/>
            <a:ext cx="26758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2. </a:t>
            </a:r>
          </a:p>
        </p:txBody>
      </p:sp>
    </p:spTree>
    <p:extLst>
      <p:ext uri="{BB962C8B-B14F-4D97-AF65-F5344CB8AC3E}">
        <p14:creationId xmlns:p14="http://schemas.microsoft.com/office/powerpoint/2010/main" val="20969630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963277EE-99FE-4702-A2AA-803C5C4549E2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278379" y="322305"/>
            <a:ext cx="3145541" cy="25326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8B1D29E-15C8-44CF-9944-563F3A111DA3}"/>
              </a:ext>
            </a:extLst>
          </p:cNvPr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423920" y="220980"/>
            <a:ext cx="3251200" cy="271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A28267E-C41E-4C77-ACAB-A20B86C0B96F}"/>
              </a:ext>
            </a:extLst>
          </p:cNvPr>
          <p:cNvSpPr txBox="1"/>
          <p:nvPr/>
        </p:nvSpPr>
        <p:spPr>
          <a:xfrm>
            <a:off x="5494360" y="876690"/>
            <a:ext cx="8578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cs typeface="Times New Roman" panose="02020603050405020304" pitchFamily="18" charset="0"/>
              </a:rPr>
              <a:t>1.81</a:t>
            </a:r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02BE7D0-17BF-465F-B3B0-559772D735E9}"/>
              </a:ext>
            </a:extLst>
          </p:cNvPr>
          <p:cNvPicPr/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78379" y="3179805"/>
            <a:ext cx="3042920" cy="25793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D7DCE38-F0DA-4018-AD92-23A116F36D6F}"/>
              </a:ext>
            </a:extLst>
          </p:cNvPr>
          <p:cNvPicPr/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538719" y="3164840"/>
            <a:ext cx="3331459" cy="271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F484CE3-2636-4C46-AE7D-60331755EFBF}"/>
              </a:ext>
            </a:extLst>
          </p:cNvPr>
          <p:cNvSpPr txBox="1"/>
          <p:nvPr/>
        </p:nvSpPr>
        <p:spPr>
          <a:xfrm>
            <a:off x="2292074" y="861861"/>
            <a:ext cx="8350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0.01%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3F7E83F-0CFD-4764-9959-8A5843E1A808}"/>
              </a:ext>
            </a:extLst>
          </p:cNvPr>
          <p:cNvSpPr txBox="1"/>
          <p:nvPr/>
        </p:nvSpPr>
        <p:spPr>
          <a:xfrm>
            <a:off x="2241014" y="3526596"/>
            <a:ext cx="8861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5.32%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CF741F9-1DEA-42BB-9B14-FBB5701D2A07}"/>
              </a:ext>
            </a:extLst>
          </p:cNvPr>
          <p:cNvSpPr txBox="1"/>
          <p:nvPr/>
        </p:nvSpPr>
        <p:spPr>
          <a:xfrm>
            <a:off x="9594182" y="3536786"/>
            <a:ext cx="8389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600" b="1" dirty="0"/>
              <a:t>5.89%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6F914C8-2609-4A21-835E-1283821CEACA}"/>
              </a:ext>
            </a:extLst>
          </p:cNvPr>
          <p:cNvSpPr txBox="1"/>
          <p:nvPr/>
        </p:nvSpPr>
        <p:spPr>
          <a:xfrm>
            <a:off x="536254" y="3242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EEF16E0-AE0F-45DB-B640-209742650491}"/>
              </a:ext>
            </a:extLst>
          </p:cNvPr>
          <p:cNvSpPr txBox="1"/>
          <p:nvPr/>
        </p:nvSpPr>
        <p:spPr>
          <a:xfrm>
            <a:off x="3899214" y="-28536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2E58A9D-A423-4FC7-977C-96187DE5392A}"/>
              </a:ext>
            </a:extLst>
          </p:cNvPr>
          <p:cNvSpPr txBox="1"/>
          <p:nvPr/>
        </p:nvSpPr>
        <p:spPr>
          <a:xfrm>
            <a:off x="7180894" y="-69176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65F4DB9-3295-4C8B-8516-557600757382}"/>
              </a:ext>
            </a:extLst>
          </p:cNvPr>
          <p:cNvSpPr txBox="1"/>
          <p:nvPr/>
        </p:nvSpPr>
        <p:spPr>
          <a:xfrm>
            <a:off x="708974" y="2887384"/>
            <a:ext cx="3679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659456C-67F2-41EE-B9B6-F374D221FA45}"/>
              </a:ext>
            </a:extLst>
          </p:cNvPr>
          <p:cNvSpPr txBox="1"/>
          <p:nvPr/>
        </p:nvSpPr>
        <p:spPr>
          <a:xfrm>
            <a:off x="3902316" y="280610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19A1534-E603-4123-9396-F04A331D5D8C}"/>
              </a:ext>
            </a:extLst>
          </p:cNvPr>
          <p:cNvSpPr txBox="1"/>
          <p:nvPr/>
        </p:nvSpPr>
        <p:spPr>
          <a:xfrm>
            <a:off x="7617774" y="291786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7C7B4F9E-2844-472F-A6C3-7924715C2A8E}"/>
              </a:ext>
            </a:extLst>
          </p:cNvPr>
          <p:cNvPicPr/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360734" y="3105632"/>
            <a:ext cx="3403600" cy="2628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03E965AC-3E89-41E4-ABB7-068ACFA84D9F}"/>
              </a:ext>
            </a:extLst>
          </p:cNvPr>
          <p:cNvPicPr/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7195478" y="202925"/>
            <a:ext cx="3147401" cy="2628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18F33330-C5DF-4615-8E48-7C5CAEA74D14}"/>
              </a:ext>
            </a:extLst>
          </p:cNvPr>
          <p:cNvSpPr txBox="1"/>
          <p:nvPr/>
        </p:nvSpPr>
        <p:spPr>
          <a:xfrm>
            <a:off x="5533953" y="3458949"/>
            <a:ext cx="9615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10.38%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60FFF7A-7D43-4612-8717-EAC320C72A0A}"/>
              </a:ext>
            </a:extLst>
          </p:cNvPr>
          <p:cNvSpPr txBox="1"/>
          <p:nvPr/>
        </p:nvSpPr>
        <p:spPr>
          <a:xfrm>
            <a:off x="9356941" y="511663"/>
            <a:ext cx="923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8.12%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4D5B21B-F9AD-4C7B-8A4D-45164550DBEE}"/>
              </a:ext>
            </a:extLst>
          </p:cNvPr>
          <p:cNvSpPr txBox="1"/>
          <p:nvPr/>
        </p:nvSpPr>
        <p:spPr>
          <a:xfrm>
            <a:off x="3779521" y="5842000"/>
            <a:ext cx="26758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3. </a:t>
            </a:r>
          </a:p>
        </p:txBody>
      </p:sp>
    </p:spTree>
    <p:extLst>
      <p:ext uri="{BB962C8B-B14F-4D97-AF65-F5344CB8AC3E}">
        <p14:creationId xmlns:p14="http://schemas.microsoft.com/office/powerpoint/2010/main" val="22402507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95DF7F5-801D-461F-932B-C6FC2D49C72F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15934" y="3095139"/>
            <a:ext cx="2871382" cy="27042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EDBF4DE-8D99-423C-B240-16666EA824EB}"/>
              </a:ext>
            </a:extLst>
          </p:cNvPr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004445" y="378331"/>
            <a:ext cx="3008663" cy="25046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21308F2-249F-478C-B460-3E681CD104FA}"/>
              </a:ext>
            </a:extLst>
          </p:cNvPr>
          <p:cNvPicPr/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6045939" y="407424"/>
            <a:ext cx="2956518" cy="2567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47BDAAF-9775-4426-9F9E-D1BE931030E5}"/>
              </a:ext>
            </a:extLst>
          </p:cNvPr>
          <p:cNvPicPr/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8992361" y="318243"/>
            <a:ext cx="2956518" cy="27679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715EC65-FB60-407E-A2A5-644B5CF54CDB}"/>
              </a:ext>
            </a:extLst>
          </p:cNvPr>
          <p:cNvPicPr/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402667" y="3119049"/>
            <a:ext cx="2871383" cy="27042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6EDEBCC-3958-44CD-835B-12859CFEB411}"/>
              </a:ext>
            </a:extLst>
          </p:cNvPr>
          <p:cNvSpPr txBox="1"/>
          <p:nvPr/>
        </p:nvSpPr>
        <p:spPr>
          <a:xfrm>
            <a:off x="536254" y="6290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64F50D2-A13B-4936-89DF-610F380DBB8A}"/>
              </a:ext>
            </a:extLst>
          </p:cNvPr>
          <p:cNvSpPr txBox="1"/>
          <p:nvPr/>
        </p:nvSpPr>
        <p:spPr>
          <a:xfrm>
            <a:off x="3360734" y="5274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870E5F2-8045-4BA1-B039-CCDD4332329A}"/>
              </a:ext>
            </a:extLst>
          </p:cNvPr>
          <p:cNvSpPr txBox="1"/>
          <p:nvPr/>
        </p:nvSpPr>
        <p:spPr>
          <a:xfrm>
            <a:off x="6469694" y="-8216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2547925-BB9E-4DDE-B1E7-5A388D58DF36}"/>
              </a:ext>
            </a:extLst>
          </p:cNvPr>
          <p:cNvSpPr txBox="1"/>
          <p:nvPr/>
        </p:nvSpPr>
        <p:spPr>
          <a:xfrm>
            <a:off x="942654" y="280610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59C379C-B64C-44B2-B404-94F00BE385EC}"/>
              </a:ext>
            </a:extLst>
          </p:cNvPr>
          <p:cNvSpPr txBox="1"/>
          <p:nvPr/>
        </p:nvSpPr>
        <p:spPr>
          <a:xfrm>
            <a:off x="9405934" y="103544"/>
            <a:ext cx="3679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EFCEAC7-3E78-436E-B1C2-1430BC07CF6A}"/>
              </a:ext>
            </a:extLst>
          </p:cNvPr>
          <p:cNvSpPr txBox="1"/>
          <p:nvPr/>
        </p:nvSpPr>
        <p:spPr>
          <a:xfrm>
            <a:off x="3838254" y="2856904"/>
            <a:ext cx="368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n-IN" sz="2400" b="1" dirty="0">
              <a:latin typeface="Arial Black" panose="020B0A040201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211920E-DF38-4833-8193-0401EB220B33}"/>
              </a:ext>
            </a:extLst>
          </p:cNvPr>
          <p:cNvSpPr txBox="1"/>
          <p:nvPr/>
        </p:nvSpPr>
        <p:spPr>
          <a:xfrm>
            <a:off x="2109801" y="637242"/>
            <a:ext cx="773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0.03%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8B2D386-18A5-40DA-BF7C-9904FE470CCF}"/>
              </a:ext>
            </a:extLst>
          </p:cNvPr>
          <p:cNvSpPr txBox="1"/>
          <p:nvPr/>
        </p:nvSpPr>
        <p:spPr>
          <a:xfrm>
            <a:off x="5149971" y="619708"/>
            <a:ext cx="8906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4.39%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4CA1F1D-41F1-40DB-B435-583ADC0ABD1E}"/>
              </a:ext>
            </a:extLst>
          </p:cNvPr>
          <p:cNvSpPr txBox="1"/>
          <p:nvPr/>
        </p:nvSpPr>
        <p:spPr>
          <a:xfrm>
            <a:off x="8007650" y="569211"/>
            <a:ext cx="9049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4.8%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4D1BCB8-1087-415A-8265-88420A1BC9FC}"/>
              </a:ext>
            </a:extLst>
          </p:cNvPr>
          <p:cNvSpPr txBox="1"/>
          <p:nvPr/>
        </p:nvSpPr>
        <p:spPr>
          <a:xfrm>
            <a:off x="11131799" y="544049"/>
            <a:ext cx="7352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8.2%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C595211-8795-45C9-BDB7-20B1C3C2E29C}"/>
              </a:ext>
            </a:extLst>
          </p:cNvPr>
          <p:cNvSpPr txBox="1"/>
          <p:nvPr/>
        </p:nvSpPr>
        <p:spPr>
          <a:xfrm>
            <a:off x="2403252" y="3483590"/>
            <a:ext cx="8032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1.83%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29B5672-C489-4549-A891-2EE9B64BBD82}"/>
              </a:ext>
            </a:extLst>
          </p:cNvPr>
          <p:cNvSpPr txBox="1"/>
          <p:nvPr/>
        </p:nvSpPr>
        <p:spPr>
          <a:xfrm>
            <a:off x="5329440" y="3441164"/>
            <a:ext cx="8484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5.12%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7D8EA145-27BB-4C60-9013-53E000858D3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8302" y="436828"/>
            <a:ext cx="2732327" cy="2389596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0FB2A442-AA5B-4124-9EAB-30105B7D94F5}"/>
              </a:ext>
            </a:extLst>
          </p:cNvPr>
          <p:cNvSpPr txBox="1"/>
          <p:nvPr/>
        </p:nvSpPr>
        <p:spPr>
          <a:xfrm>
            <a:off x="1911757" y="755539"/>
            <a:ext cx="773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0.03%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29B3C71-DC1A-4C5D-B064-30F3E6B6D0C7}"/>
              </a:ext>
            </a:extLst>
          </p:cNvPr>
          <p:cNvSpPr txBox="1"/>
          <p:nvPr/>
        </p:nvSpPr>
        <p:spPr>
          <a:xfrm>
            <a:off x="6756401" y="4734560"/>
            <a:ext cx="26758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4. </a:t>
            </a:r>
          </a:p>
        </p:txBody>
      </p:sp>
    </p:spTree>
    <p:extLst>
      <p:ext uri="{BB962C8B-B14F-4D97-AF65-F5344CB8AC3E}">
        <p14:creationId xmlns:p14="http://schemas.microsoft.com/office/powerpoint/2010/main" val="1339389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</Words>
  <Application>Microsoft Office PowerPoint</Application>
  <PresentationFormat>Widescreen</PresentationFormat>
  <Paragraphs>4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Arial Black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L-23R expression</dc:title>
  <dc:creator>Kamakshi Prudhula Devalraju</dc:creator>
  <cp:lastModifiedBy>Kamakshi Prudhula Devalraju</cp:lastModifiedBy>
  <cp:revision>68</cp:revision>
  <dcterms:created xsi:type="dcterms:W3CDTF">2018-05-09T13:20:37Z</dcterms:created>
  <dcterms:modified xsi:type="dcterms:W3CDTF">2018-06-06T04:12:41Z</dcterms:modified>
</cp:coreProperties>
</file>